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57" r:id="rId3"/>
    <p:sldId id="258" r:id="rId4"/>
    <p:sldId id="260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71" d="100"/>
          <a:sy n="71" d="100"/>
        </p:scale>
        <p:origin x="1296" y="6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A3B91-F123-4D91-90F8-F1168C8995D6}" type="datetimeFigureOut">
              <a:rPr lang="en-US" smtClean="0"/>
              <a:t>11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EFC0F-4C2A-406C-9B5D-31582008E2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2940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A3B91-F123-4D91-90F8-F1168C8995D6}" type="datetimeFigureOut">
              <a:rPr lang="en-US" smtClean="0"/>
              <a:t>11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EFC0F-4C2A-406C-9B5D-31582008E2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997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A3B91-F123-4D91-90F8-F1168C8995D6}" type="datetimeFigureOut">
              <a:rPr lang="en-US" smtClean="0"/>
              <a:t>11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EFC0F-4C2A-406C-9B5D-31582008E2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3190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A3B91-F123-4D91-90F8-F1168C8995D6}" type="datetimeFigureOut">
              <a:rPr lang="en-US" smtClean="0"/>
              <a:t>11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EFC0F-4C2A-406C-9B5D-31582008E2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9235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A3B91-F123-4D91-90F8-F1168C8995D6}" type="datetimeFigureOut">
              <a:rPr lang="en-US" smtClean="0"/>
              <a:t>11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EFC0F-4C2A-406C-9B5D-31582008E2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0478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A3B91-F123-4D91-90F8-F1168C8995D6}" type="datetimeFigureOut">
              <a:rPr lang="en-US" smtClean="0"/>
              <a:t>11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EFC0F-4C2A-406C-9B5D-31582008E2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1699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A3B91-F123-4D91-90F8-F1168C8995D6}" type="datetimeFigureOut">
              <a:rPr lang="en-US" smtClean="0"/>
              <a:t>11/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EFC0F-4C2A-406C-9B5D-31582008E2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2411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A3B91-F123-4D91-90F8-F1168C8995D6}" type="datetimeFigureOut">
              <a:rPr lang="en-US" smtClean="0"/>
              <a:t>11/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EFC0F-4C2A-406C-9B5D-31582008E2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73098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A3B91-F123-4D91-90F8-F1168C8995D6}" type="datetimeFigureOut">
              <a:rPr lang="en-US" smtClean="0"/>
              <a:t>11/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EFC0F-4C2A-406C-9B5D-31582008E2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5843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A3B91-F123-4D91-90F8-F1168C8995D6}" type="datetimeFigureOut">
              <a:rPr lang="en-US" smtClean="0"/>
              <a:t>11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EFC0F-4C2A-406C-9B5D-31582008E2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4165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A3B91-F123-4D91-90F8-F1168C8995D6}" type="datetimeFigureOut">
              <a:rPr lang="en-US" smtClean="0"/>
              <a:t>11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EFC0F-4C2A-406C-9B5D-31582008E2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61809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EA3B91-F123-4D91-90F8-F1168C8995D6}" type="datetimeFigureOut">
              <a:rPr lang="en-US" smtClean="0"/>
              <a:t>11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EFC0F-4C2A-406C-9B5D-31582008E2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2203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16" t="6973" r="5921" b="6973"/>
          <a:stretch/>
        </p:blipFill>
        <p:spPr>
          <a:xfrm>
            <a:off x="371263" y="468127"/>
            <a:ext cx="8360214" cy="5313488"/>
          </a:xfrm>
          <a:prstGeom prst="rect">
            <a:avLst/>
          </a:prstGeom>
        </p:spPr>
      </p:pic>
      <p:sp>
        <p:nvSpPr>
          <p:cNvPr id="3" name="2 Metin kutusu"/>
          <p:cNvSpPr txBox="1"/>
          <p:nvPr/>
        </p:nvSpPr>
        <p:spPr>
          <a:xfrm>
            <a:off x="981581" y="5781615"/>
            <a:ext cx="71395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valence of WNV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ro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positivity by zip code in asymptomatic subjects in El Paso, Texa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ArcGI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.7.0 (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SRI Inc., Redlands, CA) was used for illustrativ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urposes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75970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31089" y="298225"/>
            <a:ext cx="2984379" cy="2285756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3"/>
          <a:srcRect l="2014"/>
          <a:stretch/>
        </p:blipFill>
        <p:spPr>
          <a:xfrm>
            <a:off x="31907" y="404920"/>
            <a:ext cx="3136372" cy="216688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45296" y="2917118"/>
            <a:ext cx="3182926" cy="2339321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5"/>
          <a:srcRect l="3035"/>
          <a:stretch/>
        </p:blipFill>
        <p:spPr>
          <a:xfrm>
            <a:off x="-1046" y="2960115"/>
            <a:ext cx="3007862" cy="2279851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6"/>
          <a:srcRect l="3516" t="4298"/>
          <a:stretch/>
        </p:blipFill>
        <p:spPr>
          <a:xfrm>
            <a:off x="6081039" y="3042313"/>
            <a:ext cx="3037203" cy="2214126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181276" y="149675"/>
            <a:ext cx="3696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350311" y="149675"/>
            <a:ext cx="3696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7"/>
          <a:srcRect l="3327"/>
          <a:stretch/>
        </p:blipFill>
        <p:spPr>
          <a:xfrm>
            <a:off x="6144381" y="214880"/>
            <a:ext cx="2976065" cy="2389879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6247498" y="147425"/>
            <a:ext cx="3696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94774" y="2765186"/>
            <a:ext cx="3696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165504" y="2765185"/>
            <a:ext cx="3696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6211520" y="2765184"/>
            <a:ext cx="3696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" name="Rectangle 1"/>
          <p:cNvSpPr/>
          <p:nvPr/>
        </p:nvSpPr>
        <p:spPr>
          <a:xfrm>
            <a:off x="281221" y="5340320"/>
            <a:ext cx="8490639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2: Sera samples from symptomatic WNV seropositive donors cause enhancement of ZIKV</a:t>
            </a:r>
            <a:r>
              <a:rPr lang="en-US" sz="1200" b="1" i="0" u="none" strike="noStrik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infection. </a:t>
            </a:r>
            <a:r>
              <a:rPr lang="en-US" sz="1200" b="0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Vero cells were infected with </a:t>
            </a:r>
            <a:r>
              <a:rPr lang="en-US" sz="1200" b="1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sz="1200" b="0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WNV </a:t>
            </a:r>
            <a:r>
              <a:rPr lang="en-US" sz="1200" b="1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200" b="0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ZIKV or </a:t>
            </a:r>
            <a:r>
              <a:rPr lang="en-US" sz="1200" b="1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sz="1200" b="0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DENV RVPs in the presence of media alone or serial</a:t>
            </a:r>
            <a:r>
              <a:rPr lang="en-US" sz="1200" b="0" i="0" u="none" strike="noStrik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0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dilutions of WNV+ sera samples obtained from symptomatic donors. The number of GFP positive cells was analyzed</a:t>
            </a:r>
            <a:r>
              <a:rPr lang="en-US" sz="1200" b="0" i="0" u="none" strike="noStrik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0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72h post infection. All wells were assayed in duplicates and graphs were plotted after normalizing data to 100% infection</a:t>
            </a:r>
            <a:r>
              <a:rPr lang="en-US" sz="1200" b="0" i="0" u="none" strike="noStrik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0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in the absence of any sera. K562 cells were infected with </a:t>
            </a:r>
            <a:r>
              <a:rPr lang="en-US" sz="1200" b="1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n-US" sz="1200" b="0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WNV, </a:t>
            </a:r>
            <a:r>
              <a:rPr lang="en-US" sz="1200" b="1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(E) </a:t>
            </a:r>
            <a:r>
              <a:rPr lang="en-US" sz="1200" b="0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ZIKV or </a:t>
            </a:r>
            <a:r>
              <a:rPr lang="en-US" sz="1200" b="1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(F) </a:t>
            </a:r>
            <a:r>
              <a:rPr lang="en-US" sz="1200" b="0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DENV RVPs in the presence of</a:t>
            </a:r>
            <a:r>
              <a:rPr lang="en-US" sz="1200" b="0" i="0" u="none" strike="noStrik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0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WNV+ sera samples from symptomatic donors. The number of GFP positive cells was analyzed 48h post infection. All</a:t>
            </a:r>
            <a:r>
              <a:rPr lang="en-US" sz="1200" b="0" i="0" u="none" strike="noStrik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0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wells were assayed in duplicates and graphs were plotted after normalizing data to peak ADE as 100% infection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187533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846412" y="932247"/>
            <a:ext cx="3497586" cy="3912721"/>
            <a:chOff x="846412" y="1176948"/>
            <a:chExt cx="3497586" cy="3912721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46412" y="1330377"/>
              <a:ext cx="3497586" cy="3759292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202796" y="1176948"/>
              <a:ext cx="3696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3" name="Rectangle 2"/>
            <p:cNvSpPr/>
            <p:nvPr/>
          </p:nvSpPr>
          <p:spPr>
            <a:xfrm>
              <a:off x="1762900" y="1330377"/>
              <a:ext cx="1441622" cy="67141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4656241" y="925555"/>
            <a:ext cx="3663975" cy="3839669"/>
            <a:chOff x="4656241" y="1170256"/>
            <a:chExt cx="3663975" cy="3839669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656241" y="1429233"/>
              <a:ext cx="3663975" cy="3580692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4782129" y="1170256"/>
              <a:ext cx="3696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9" name="Rectangle 8"/>
            <p:cNvSpPr/>
            <p:nvPr/>
          </p:nvSpPr>
          <p:spPr>
            <a:xfrm>
              <a:off x="5586336" y="1325231"/>
              <a:ext cx="1441622" cy="67141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1" name="Rectangle 10"/>
          <p:cNvSpPr/>
          <p:nvPr/>
        </p:nvSpPr>
        <p:spPr>
          <a:xfrm>
            <a:off x="1094995" y="4948970"/>
            <a:ext cx="7044744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3: </a:t>
            </a:r>
            <a:r>
              <a:rPr lang="en-US" sz="1200" b="0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Sera obtained from symptomatic and asymptomatic WNV</a:t>
            </a:r>
            <a:r>
              <a:rPr lang="en-US" sz="1200" b="0" i="0" u="none" strike="noStrik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0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seropositive donors causes ZIKV enhancement with minimal neutralization. </a:t>
            </a:r>
            <a:r>
              <a:rPr lang="en-US" sz="1200" b="1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sz="1200" b="0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Sera samples</a:t>
            </a:r>
            <a:r>
              <a:rPr lang="en-US" sz="1200" b="0" i="0" u="none" strike="noStrik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0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from symptomatic and asymptomatic WNV seropositive donors were analyzed for neutralization</a:t>
            </a:r>
            <a:r>
              <a:rPr lang="en-US" sz="1200" b="0" i="0" u="none" strike="noStrik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0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of ZIKV, WNV and DENV infection. Dilution of serum causing 50% neutralization of respective</a:t>
            </a:r>
            <a:r>
              <a:rPr lang="en-US" sz="1200" b="0" i="0" u="none" strike="noStrik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0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RVPs was determined. </a:t>
            </a:r>
            <a:r>
              <a:rPr lang="en-US" sz="1200" b="1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200" b="0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Sera samples from symptomatic and asymptomatic WNV</a:t>
            </a:r>
            <a:r>
              <a:rPr lang="en-US" sz="1200" b="0" i="0" u="none" strike="noStrik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0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seropositive donors were analyzed for</a:t>
            </a:r>
            <a:r>
              <a:rPr lang="en-US" sz="1200" b="0" i="0" u="none" strike="noStrik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0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enhancement of ZIKV, WNV and DENV infection. Dilution</a:t>
            </a:r>
            <a:r>
              <a:rPr lang="en-US" sz="1200" b="0" i="0" u="none" strike="noStrik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0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of serum causing peak ADE for respective RVPs was determine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82476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16927" t="20032" r="15406" b="29287"/>
          <a:stretch/>
        </p:blipFill>
        <p:spPr>
          <a:xfrm>
            <a:off x="2656705" y="740191"/>
            <a:ext cx="4061254" cy="2433431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l="17204" t="26433" r="14575" b="23016"/>
          <a:stretch/>
        </p:blipFill>
        <p:spPr>
          <a:xfrm>
            <a:off x="2656705" y="3797640"/>
            <a:ext cx="4061254" cy="24075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 rot="16200000">
            <a:off x="2245345" y="100355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MP00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 rot="16200000">
            <a:off x="2462934" y="100355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MP00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6200000">
            <a:off x="2671604" y="100354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MP003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6200000">
            <a:off x="2851124" y="100354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MP004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3046000" y="100354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MP00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3232675" y="108607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MP006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 rot="16200000">
            <a:off x="3434263" y="100354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MP007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6200000">
            <a:off x="3637799" y="100354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MP008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3828158" y="108607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MP009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4014996" y="108607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MP01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4382364" y="108606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MP01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4191878" y="108606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MP01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16200000">
            <a:off x="4584404" y="108594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MP013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 rot="16200000">
            <a:off x="4782854" y="108594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MP014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16200000">
            <a:off x="5947647" y="116830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MP01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4967514" y="116826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MP016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rot="16200000">
            <a:off x="5162059" y="111515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MP017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6200000">
            <a:off x="5350499" y="108593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MP018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6200000">
            <a:off x="5558490" y="116826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MP019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6200000">
            <a:off x="5755995" y="125059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MP02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6646013" y="1666964"/>
            <a:ext cx="835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E</a:t>
            </a:r>
          </a:p>
        </p:txBody>
      </p:sp>
      <p:sp>
        <p:nvSpPr>
          <p:cNvPr id="25" name="TextBox 24"/>
          <p:cNvSpPr txBox="1"/>
          <p:nvPr/>
        </p:nvSpPr>
        <p:spPr>
          <a:xfrm rot="16200000">
            <a:off x="2247484" y="3155427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SY02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2435506" y="3155427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SY036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 rot="16200000">
            <a:off x="2620068" y="3155427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SY053</a:t>
            </a:r>
          </a:p>
        </p:txBody>
      </p:sp>
      <p:sp>
        <p:nvSpPr>
          <p:cNvPr id="28" name="TextBox 27"/>
          <p:cNvSpPr txBox="1"/>
          <p:nvPr/>
        </p:nvSpPr>
        <p:spPr>
          <a:xfrm rot="16200000">
            <a:off x="2823769" y="3155425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SY078</a:t>
            </a:r>
          </a:p>
        </p:txBody>
      </p:sp>
      <p:sp>
        <p:nvSpPr>
          <p:cNvPr id="29" name="TextBox 28"/>
          <p:cNvSpPr txBox="1"/>
          <p:nvPr/>
        </p:nvSpPr>
        <p:spPr>
          <a:xfrm rot="16200000">
            <a:off x="3018573" y="3155425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SY110</a:t>
            </a:r>
          </a:p>
        </p:txBody>
      </p:sp>
      <p:sp>
        <p:nvSpPr>
          <p:cNvPr id="30" name="TextBox 29"/>
          <p:cNvSpPr txBox="1"/>
          <p:nvPr/>
        </p:nvSpPr>
        <p:spPr>
          <a:xfrm rot="16200000">
            <a:off x="3213377" y="3147171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SY127</a:t>
            </a:r>
          </a:p>
        </p:txBody>
      </p:sp>
      <p:sp>
        <p:nvSpPr>
          <p:cNvPr id="31" name="TextBox 30"/>
          <p:cNvSpPr txBox="1"/>
          <p:nvPr/>
        </p:nvSpPr>
        <p:spPr>
          <a:xfrm rot="16200000">
            <a:off x="3588075" y="3163647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SY141</a:t>
            </a:r>
          </a:p>
        </p:txBody>
      </p:sp>
      <p:sp>
        <p:nvSpPr>
          <p:cNvPr id="32" name="TextBox 31"/>
          <p:cNvSpPr txBox="1"/>
          <p:nvPr/>
        </p:nvSpPr>
        <p:spPr>
          <a:xfrm rot="16200000">
            <a:off x="3397549" y="3155425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SY150</a:t>
            </a:r>
          </a:p>
        </p:txBody>
      </p:sp>
      <p:sp>
        <p:nvSpPr>
          <p:cNvPr id="33" name="TextBox 32"/>
          <p:cNvSpPr txBox="1"/>
          <p:nvPr/>
        </p:nvSpPr>
        <p:spPr>
          <a:xfrm rot="16200000">
            <a:off x="3784189" y="3163647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SY224</a:t>
            </a:r>
          </a:p>
        </p:txBody>
      </p:sp>
      <p:sp>
        <p:nvSpPr>
          <p:cNvPr id="34" name="TextBox 33"/>
          <p:cNvSpPr txBox="1"/>
          <p:nvPr/>
        </p:nvSpPr>
        <p:spPr>
          <a:xfrm rot="16200000">
            <a:off x="3971721" y="3155429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SY239</a:t>
            </a:r>
          </a:p>
        </p:txBody>
      </p:sp>
      <p:sp>
        <p:nvSpPr>
          <p:cNvPr id="35" name="TextBox 34"/>
          <p:cNvSpPr txBox="1"/>
          <p:nvPr/>
        </p:nvSpPr>
        <p:spPr>
          <a:xfrm rot="16200000">
            <a:off x="4164326" y="3155427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SY282</a:t>
            </a:r>
          </a:p>
        </p:txBody>
      </p:sp>
      <p:sp>
        <p:nvSpPr>
          <p:cNvPr id="36" name="TextBox 35"/>
          <p:cNvSpPr txBox="1"/>
          <p:nvPr/>
        </p:nvSpPr>
        <p:spPr>
          <a:xfrm rot="16200000">
            <a:off x="4362307" y="3155414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SY284</a:t>
            </a:r>
          </a:p>
        </p:txBody>
      </p:sp>
      <p:sp>
        <p:nvSpPr>
          <p:cNvPr id="37" name="TextBox 36"/>
          <p:cNvSpPr txBox="1"/>
          <p:nvPr/>
        </p:nvSpPr>
        <p:spPr>
          <a:xfrm rot="16200000">
            <a:off x="4548496" y="3147170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SY311</a:t>
            </a:r>
          </a:p>
        </p:txBody>
      </p:sp>
      <p:sp>
        <p:nvSpPr>
          <p:cNvPr id="38" name="TextBox 37"/>
          <p:cNvSpPr txBox="1"/>
          <p:nvPr/>
        </p:nvSpPr>
        <p:spPr>
          <a:xfrm rot="16200000">
            <a:off x="4729876" y="3155414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SY316</a:t>
            </a:r>
          </a:p>
        </p:txBody>
      </p:sp>
      <p:sp>
        <p:nvSpPr>
          <p:cNvPr id="39" name="TextBox 38"/>
          <p:cNvSpPr txBox="1"/>
          <p:nvPr/>
        </p:nvSpPr>
        <p:spPr>
          <a:xfrm rot="16200000">
            <a:off x="5896160" y="3151153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SY383</a:t>
            </a:r>
          </a:p>
        </p:txBody>
      </p:sp>
      <p:sp>
        <p:nvSpPr>
          <p:cNvPr id="40" name="TextBox 39"/>
          <p:cNvSpPr txBox="1"/>
          <p:nvPr/>
        </p:nvSpPr>
        <p:spPr>
          <a:xfrm rot="16200000">
            <a:off x="4923193" y="3147169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SY317</a:t>
            </a:r>
          </a:p>
        </p:txBody>
      </p:sp>
      <p:sp>
        <p:nvSpPr>
          <p:cNvPr id="41" name="TextBox 40"/>
          <p:cNvSpPr txBox="1"/>
          <p:nvPr/>
        </p:nvSpPr>
        <p:spPr>
          <a:xfrm rot="16200000">
            <a:off x="5110841" y="3147169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SY322</a:t>
            </a:r>
          </a:p>
        </p:txBody>
      </p:sp>
      <p:sp>
        <p:nvSpPr>
          <p:cNvPr id="42" name="TextBox 41"/>
          <p:cNvSpPr txBox="1"/>
          <p:nvPr/>
        </p:nvSpPr>
        <p:spPr>
          <a:xfrm rot="16200000">
            <a:off x="5324049" y="3147169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SY354</a:t>
            </a:r>
          </a:p>
        </p:txBody>
      </p:sp>
      <p:sp>
        <p:nvSpPr>
          <p:cNvPr id="43" name="TextBox 42"/>
          <p:cNvSpPr txBox="1"/>
          <p:nvPr/>
        </p:nvSpPr>
        <p:spPr>
          <a:xfrm rot="16200000">
            <a:off x="5514609" y="3155411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SY356</a:t>
            </a:r>
          </a:p>
        </p:txBody>
      </p:sp>
      <p:sp>
        <p:nvSpPr>
          <p:cNvPr id="44" name="TextBox 43"/>
          <p:cNvSpPr txBox="1"/>
          <p:nvPr/>
        </p:nvSpPr>
        <p:spPr>
          <a:xfrm rot="16200000">
            <a:off x="5700191" y="3155409"/>
            <a:ext cx="1194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SY382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6646013" y="4619628"/>
            <a:ext cx="835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E</a:t>
            </a:r>
          </a:p>
        </p:txBody>
      </p:sp>
      <p:sp>
        <p:nvSpPr>
          <p:cNvPr id="46" name="Rectangle 45"/>
          <p:cNvSpPr/>
          <p:nvPr/>
        </p:nvSpPr>
        <p:spPr>
          <a:xfrm>
            <a:off x="2711915" y="6205149"/>
            <a:ext cx="45720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200" b="1" i="0" u="none" strike="noStrike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4:</a:t>
            </a:r>
            <a:r>
              <a:rPr lang="en-US" sz="1200" b="1" i="0" u="none" strike="noStrik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0" u="none" strike="noStrike" dirty="0" smtClean="0">
                <a:latin typeface="Arial" panose="020B0604020202020204" pitchFamily="34" charset="0"/>
                <a:cs typeface="Arial" panose="020B0604020202020204" pitchFamily="34" charset="0"/>
              </a:rPr>
              <a:t>Uncropped gels for Figure 8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37048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07</TotalTime>
  <Words>345</Words>
  <Application>Microsoft Office PowerPoint</Application>
  <PresentationFormat>On-screen Show (4:3)</PresentationFormat>
  <Paragraphs>5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jali Joshi</dc:creator>
  <cp:lastModifiedBy>Anjali Joshi</cp:lastModifiedBy>
  <cp:revision>12</cp:revision>
  <dcterms:created xsi:type="dcterms:W3CDTF">2020-08-23T14:00:18Z</dcterms:created>
  <dcterms:modified xsi:type="dcterms:W3CDTF">2020-11-01T15:18:29Z</dcterms:modified>
</cp:coreProperties>
</file>